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8C8179-AC41-463A-A84A-1C45A439B65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6F7B76-3B38-45EA-973A-8D3013A812E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B80A6A-B035-48A2-A3DE-1B99F2930C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C3C0C-0BBC-4232-A309-B1D34A1987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A737F0-5B79-4589-ADF5-21A726C68C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6F2DC3-7E8F-4129-BB96-7449ED42F3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8F18D4-F68D-4C45-9B78-8663907E42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2BFB5A-1F7D-4624-B0A5-AB9B71EBF3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3CF5B4-92F5-44C6-A093-824A18C742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EA6D86-B28C-44A0-AF29-C21A622425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D91AF6-0D97-42C4-BDDA-340B6926BE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95E41-6C98-44CF-B3B1-C9D800A518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E21165-7F80-484E-BE76-28EAF652EF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2F422E-02A5-4B38-9453-8408E7BB73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636510-63E5-4A67-AEBD-8B7388BD54B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533520" y="1143000"/>
          <a:ext cx="7912080" cy="4975200"/>
        </p:xfrm>
        <a:graphic>
          <a:graphicData uri="http://schemas.openxmlformats.org/drawingml/2006/table">
            <a:tbl>
              <a:tblPr/>
              <a:tblGrid>
                <a:gridCol w="361800"/>
                <a:gridCol w="714240"/>
                <a:gridCol w="301680"/>
                <a:gridCol w="432000"/>
                <a:gridCol w="298440"/>
                <a:gridCol w="826920"/>
                <a:gridCol w="417600"/>
                <a:gridCol w="304920"/>
                <a:gridCol w="419040"/>
                <a:gridCol w="295200"/>
                <a:gridCol w="784080"/>
                <a:gridCol w="406440"/>
                <a:gridCol w="304920"/>
                <a:gridCol w="419040"/>
                <a:gridCol w="304920"/>
                <a:gridCol w="863640"/>
                <a:gridCol w="457200"/>
              </a:tblGrid>
              <a:tr h="549360">
                <a:tc gridSpan="17">
                  <a:txBody>
                    <a:bodyPr lIns="27360" rIns="273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ditional file 1:  Table S1: The association of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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tocopherol (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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T) and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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tocopherol (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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T) with lung spirometry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ith adjustment for other tocopherol isoform.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Linear regression analysis at year 0 of the CARDIA study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58840">
                <a:tc rowSpan="2"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u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pirometr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5"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LACKS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5"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HITES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5"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LL PARTICIPANTS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17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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% Confidence Interval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alu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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nfidence Interval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alu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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nfidence Interval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alu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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8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5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4640"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V</a:t>
                      </a:r>
                      <a:r>
                        <a:rPr b="1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3 to 68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5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0.7 to 33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7.6 to 34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7320"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V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9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.1 to 88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 to 65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.2 to 59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6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</a:tr>
              <a:tr h="361800"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V</a:t>
                      </a:r>
                      <a:r>
                        <a:rPr b="1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/FV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6 to 0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8 to -0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6 to 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 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#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</a:tr>
              <a:tr h="244440"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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8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5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0360"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V</a:t>
                      </a:r>
                      <a:r>
                        <a:rPr b="1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91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8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66.2 to -16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78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7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71.1 to 13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0 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#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77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35.1 to -18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</a:tr>
              <a:tr h="396720"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V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23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3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8.1 to -38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5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11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4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18.6 to -3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05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72.6 to -38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2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0c0c0"/>
                    </a:solidFill>
                  </a:tcPr>
                </a:tc>
              </a:tr>
              <a:tr h="360360"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V</a:t>
                      </a:r>
                      <a:r>
                        <a:rPr b="1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/FV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8 to 1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0 to 1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 algn="ctr"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5 to 1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851040">
                <a:tc gridSpan="17">
                  <a:txBody>
                    <a:bodyPr lIns="27360" rIns="2736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 </a:t>
                      </a:r>
                      <a:r>
                        <a:rPr b="1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justments: other tocopherol isoform, center, age, age</a:t>
                      </a:r>
                      <a:r>
                        <a:rPr b="1" lang="en-US" sz="9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height, height</a:t>
                      </a:r>
                      <a:r>
                        <a:rPr b="1" lang="en-US" sz="9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sex, BMI, smoking status and ever asthm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</a:t>
                      </a:r>
                      <a:r>
                        <a:rPr b="1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b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Adjustments: other tocopherol isoform, center, age, age</a:t>
                      </a:r>
                      <a:r>
                        <a:rPr b="1" lang="en-US" sz="9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height, height</a:t>
                      </a:r>
                      <a:r>
                        <a:rPr b="1" lang="en-US" sz="9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sex, BMI, smoking status and ever asthma, rac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 </a:t>
                      </a:r>
                      <a:r>
                        <a:rPr b="1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,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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is the difference in mL of FEV1, mL of FVC or % FEV1/FVC per 10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µM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tocopherol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*,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nificant; </a:t>
                      </a:r>
                      <a:r>
                        <a:rPr b="1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#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en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360" marR="2736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21T16:02:19Z</dcterms:created>
  <dc:creator>Joan Cook-Mills</dc:creator>
  <dc:description/>
  <dc:language>en-US</dc:language>
  <cp:lastModifiedBy>jepartosa</cp:lastModifiedBy>
  <dcterms:modified xsi:type="dcterms:W3CDTF">2014-03-03T19:03:10Z</dcterms:modified>
  <cp:revision>16</cp:revision>
  <dc:subject/>
  <dc:title>Slide 1</dc:title>
</cp:coreProperties>
</file>